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589" y="-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494BDC-55A3-4BA8-8179-A1E1E6EBEC2C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3934C4-1469-406F-9BD4-BF976DD055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2513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6102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5253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23849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737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435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007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9254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927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208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5730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1878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5277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785" y="107504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9</a:t>
            </a:r>
            <a:endParaRPr lang="en-GB" b="1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42896912"/>
              </p:ext>
            </p:extLst>
          </p:nvPr>
        </p:nvGraphicFramePr>
        <p:xfrm>
          <a:off x="666946" y="611560"/>
          <a:ext cx="609600" cy="4754880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609600"/>
              </a:tblGrid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Symbol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CD27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CXCL1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GBP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GBP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GBP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FI1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IFI3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FI4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IFI44L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FI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FIH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FIT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FIT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FIT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FITM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FITM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RF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OAS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OAS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OAS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SOCS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STAT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STAT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TAP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TAP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667702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28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oom</dc:creator>
  <cp:lastModifiedBy>Bloom</cp:lastModifiedBy>
  <cp:revision>10</cp:revision>
  <dcterms:created xsi:type="dcterms:W3CDTF">2013-03-09T22:22:05Z</dcterms:created>
  <dcterms:modified xsi:type="dcterms:W3CDTF">2013-03-09T22:33:31Z</dcterms:modified>
</cp:coreProperties>
</file>